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1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800EE-356F-703A-6E98-7F9B51257E3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7B7A9C-75E3-3766-355C-50BFCA8E37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2C0C3-C865-D08E-9315-59ABFE44A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A8D42E-93DC-334C-CF2D-737D13412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FDF33-B969-1FC7-D676-F9AC007A4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601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75D07-C5B4-6CDA-AF09-B7B620EA71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F1BADA-3DCF-CF8F-1199-DD459D5C8F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1BFB9B-47EE-5DE5-0E1A-96CF17819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1D55D-B268-3DF2-5A97-ADB4CE5F1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3C853B-8326-2FEB-9C40-E08E70440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50230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9C8C41-3B7A-4B31-6D59-9621E846F7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C971E6-6847-EBD0-BCE9-C5DBAAF103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26422-19EE-E81F-7116-56D2069AF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914EC2-8A71-D6B3-16AC-8017BB0DF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49E1A2-C699-D3D7-53CF-5218321F2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0979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12A3D5-AE3A-5AF8-20F7-8462CA1E76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8453A9-9881-A454-C31A-2C1A60191B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9817D-B352-3D54-8A4B-52D106274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428981-C160-BD60-A1A6-3929DC6ED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9882D2-7284-E13A-8302-49702D623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98776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A399E-B71C-EAC8-7F54-AC4E7F7C09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91AA55-CC4C-E37F-5AB7-408E6A3D80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97ECD-B0E4-9BA3-5DC7-4B9D1584D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E13FC4-F846-894B-2458-00B1C0801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D2F278-4412-F18D-D31F-E98284758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58765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4C61C8-4B73-0B3A-2056-9881E2634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F3867A-9957-71EA-3BCC-E4D98C8C9A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48F9CB-1E9A-3ED2-561B-4D14C3D6ED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D1C579-7F0C-59FF-2ACB-F10BA3183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3ABA16-ACE7-DC57-43A6-C059B50E8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ACEEBD-00E1-D1B1-E405-06E58C58B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68972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43C99E-08F0-852A-066A-60D29A5A9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AE93F2-6B40-823A-177E-5F6DC31BEC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ABC142-CED0-B298-774C-8832F3FC13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4FD5A72-6FC4-B51C-8D9E-705A78AF3E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F13A9E-9934-63D8-BFB8-93292C9AC7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A55947-8C9D-AEDE-D058-B7C07019E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0B3C03-88E3-4984-80F0-17C4952CB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F754EA8-BC37-8174-8AC5-B5A950B65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78542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12E177-6BC7-17B3-D129-7BE309EDAB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81169A-F2CA-F3C4-48C6-AC90B7C38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57DFBD-EFE2-5254-06D0-644F1770F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00A8F6-A622-F032-71D7-9AB6B20D4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48901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8911E1-D3AB-0EF9-CAA4-F86629286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C5FDEE9-D79A-E50D-F73C-0EF582481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FAE346-5F13-B289-CC7E-E4F1BA43B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87282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AFC9F-8EBD-9E5C-2BBF-8FBF58F980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2526A0-0218-6E57-6017-77A1361F7C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D38777-0323-05CA-ADFC-552BCBFB40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D30917-4FE3-0CBE-137B-C37CDCE6F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D03D77-B513-5EE6-28E1-E9943FFE7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1FEA3C-7C71-DE84-9EA2-C8C50F112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00822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07775-14CB-5826-5382-71259F00B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3CDC05D-EAF7-8F85-9AD5-FB723D271D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B19E0D-568E-0468-A0B1-91652314B1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4E7E2C-60B7-9A49-20AA-79DBC2F7A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A60477-17DA-DE5E-58AB-F9D45369D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2225C2-BC11-552E-023E-2E1F0B329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94707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809782-74E2-178A-1CC3-C1DECE1A0C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DF49E3-B828-2032-EBEB-B8896BD5EA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CBDB8E-6DF8-D4BE-A185-159437321F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53835E-CEA1-DD79-F347-DF2935AE26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16B69A-21BE-E065-37EF-ABB08FF0F5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84800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Picture 110" descr="A close-up of a dna test&#10;&#10;Description automatically generated">
            <a:extLst>
              <a:ext uri="{FF2B5EF4-FFF2-40B4-BE49-F238E27FC236}">
                <a16:creationId xmlns:a16="http://schemas.microsoft.com/office/drawing/2014/main" id="{12B82796-8383-CAE1-890F-7FB7C3E04894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2064" y="3090151"/>
            <a:ext cx="4114575" cy="2499764"/>
          </a:xfrm>
          <a:prstGeom prst="rect">
            <a:avLst/>
          </a:prstGeom>
        </p:spPr>
      </p:pic>
      <p:sp>
        <p:nvSpPr>
          <p:cNvPr id="4" name="TextBox 11">
            <a:extLst>
              <a:ext uri="{FF2B5EF4-FFF2-40B4-BE49-F238E27FC236}">
                <a16:creationId xmlns:a16="http://schemas.microsoft.com/office/drawing/2014/main" id="{4555A8AB-4711-8C87-BF0A-586C8B33E92D}"/>
              </a:ext>
            </a:extLst>
          </p:cNvPr>
          <p:cNvSpPr txBox="1"/>
          <p:nvPr/>
        </p:nvSpPr>
        <p:spPr bwMode="auto">
          <a:xfrm>
            <a:off x="280442" y="297573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600" b="1" dirty="0">
                <a:latin typeface="Arial"/>
                <a:cs typeface="Arial"/>
              </a:rPr>
              <a:t>Figure 6D</a:t>
            </a:r>
            <a:endParaRPr sz="1600" b="1" dirty="0">
              <a:latin typeface="Arial"/>
              <a:cs typeface="Arial"/>
            </a:endParaRPr>
          </a:p>
        </p:txBody>
      </p:sp>
      <p:sp>
        <p:nvSpPr>
          <p:cNvPr id="5" name="TextBox 11">
            <a:extLst>
              <a:ext uri="{FF2B5EF4-FFF2-40B4-BE49-F238E27FC236}">
                <a16:creationId xmlns:a16="http://schemas.microsoft.com/office/drawing/2014/main" id="{A70DF59F-2A8D-5D12-B6A7-0D5E4C4D1170}"/>
              </a:ext>
            </a:extLst>
          </p:cNvPr>
          <p:cNvSpPr txBox="1"/>
          <p:nvPr/>
        </p:nvSpPr>
        <p:spPr bwMode="auto">
          <a:xfrm>
            <a:off x="3282619" y="5657470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400" dirty="0">
                <a:solidFill>
                  <a:srgbClr val="FF0000"/>
                </a:solidFill>
                <a:latin typeface="Arial"/>
                <a:cs typeface="Arial"/>
              </a:rPr>
              <a:t>ZBP1</a:t>
            </a:r>
            <a:r>
              <a:rPr lang="en-US" sz="1400" dirty="0">
                <a:latin typeface="Arial"/>
                <a:cs typeface="Arial"/>
              </a:rPr>
              <a:t> (SE)</a:t>
            </a:r>
            <a:endParaRPr sz="4000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1DB4856-8857-5227-0A69-8325610085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/>
        </p:blipFill>
        <p:spPr bwMode="auto">
          <a:xfrm>
            <a:off x="2105194" y="3139841"/>
            <a:ext cx="3631162" cy="2510065"/>
          </a:xfrm>
          <a:prstGeom prst="rect">
            <a:avLst/>
          </a:prstGeom>
        </p:spPr>
      </p:pic>
      <p:sp>
        <p:nvSpPr>
          <p:cNvPr id="17" name="TextBox 11">
            <a:extLst>
              <a:ext uri="{FF2B5EF4-FFF2-40B4-BE49-F238E27FC236}">
                <a16:creationId xmlns:a16="http://schemas.microsoft.com/office/drawing/2014/main" id="{68ED998A-E039-2750-F3B3-270E6587E1F1}"/>
              </a:ext>
            </a:extLst>
          </p:cNvPr>
          <p:cNvSpPr txBox="1"/>
          <p:nvPr/>
        </p:nvSpPr>
        <p:spPr bwMode="auto">
          <a:xfrm>
            <a:off x="8193102" y="5656056"/>
            <a:ext cx="10214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400" dirty="0">
                <a:solidFill>
                  <a:srgbClr val="FF0000"/>
                </a:solidFill>
                <a:latin typeface="Arial"/>
                <a:cs typeface="Arial"/>
              </a:rPr>
              <a:t>ZBP1</a:t>
            </a:r>
            <a:r>
              <a:rPr lang="en-US" sz="1400" dirty="0">
                <a:latin typeface="Arial"/>
                <a:cs typeface="Arial"/>
              </a:rPr>
              <a:t> (LE)</a:t>
            </a:r>
            <a:endParaRPr sz="4000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E6C1254-0056-4FB3-FF81-CE67B16E48DD}"/>
              </a:ext>
            </a:extLst>
          </p:cNvPr>
          <p:cNvSpPr/>
          <p:nvPr/>
        </p:nvSpPr>
        <p:spPr>
          <a:xfrm>
            <a:off x="2520942" y="3563618"/>
            <a:ext cx="1523355" cy="6980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1ABA553-863C-C51E-1B04-5AE24BC835B5}"/>
              </a:ext>
            </a:extLst>
          </p:cNvPr>
          <p:cNvSpPr/>
          <p:nvPr/>
        </p:nvSpPr>
        <p:spPr>
          <a:xfrm>
            <a:off x="8766316" y="3436401"/>
            <a:ext cx="1395649" cy="6980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9A3CF11-FDD5-8C08-BA8C-F822AC3FD3E7}"/>
              </a:ext>
            </a:extLst>
          </p:cNvPr>
          <p:cNvSpPr txBox="1"/>
          <p:nvPr/>
        </p:nvSpPr>
        <p:spPr>
          <a:xfrm>
            <a:off x="3008374" y="1110135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J2 IP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81D82A8-461F-2F67-8A84-BF45DF261100}"/>
              </a:ext>
            </a:extLst>
          </p:cNvPr>
          <p:cNvSpPr txBox="1"/>
          <p:nvPr/>
        </p:nvSpPr>
        <p:spPr>
          <a:xfrm rot="16200000">
            <a:off x="3677034" y="322367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A41E5C6D-CB89-7443-FEB2-A563DC8FABB6}"/>
              </a:ext>
            </a:extLst>
          </p:cNvPr>
          <p:cNvCxnSpPr>
            <a:cxnSpLocks/>
          </p:cNvCxnSpPr>
          <p:nvPr/>
        </p:nvCxnSpPr>
        <p:spPr>
          <a:xfrm flipV="1">
            <a:off x="2527737" y="1354727"/>
            <a:ext cx="1482722" cy="22148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077AFB60-B9F0-EAE2-33CA-48F782BE01FD}"/>
              </a:ext>
            </a:extLst>
          </p:cNvPr>
          <p:cNvSpPr txBox="1"/>
          <p:nvPr/>
        </p:nvSpPr>
        <p:spPr>
          <a:xfrm>
            <a:off x="4621438" y="1070501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0941693-B8B7-CF81-C09B-1AA6509028CE}"/>
              </a:ext>
            </a:extLst>
          </p:cNvPr>
          <p:cNvSpPr txBox="1"/>
          <p:nvPr/>
        </p:nvSpPr>
        <p:spPr>
          <a:xfrm rot="16200000">
            <a:off x="2189304" y="2944707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1F9FAB5-E9A8-BAF4-44F6-A44EA10C5AEB}"/>
              </a:ext>
            </a:extLst>
          </p:cNvPr>
          <p:cNvSpPr txBox="1"/>
          <p:nvPr/>
        </p:nvSpPr>
        <p:spPr>
          <a:xfrm rot="16200000">
            <a:off x="2274749" y="2785821"/>
            <a:ext cx="1295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L-NG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30F20DC-8E1B-787C-41C3-F777B12EB136}"/>
              </a:ext>
            </a:extLst>
          </p:cNvPr>
          <p:cNvSpPr txBox="1"/>
          <p:nvPr/>
        </p:nvSpPr>
        <p:spPr>
          <a:xfrm rot="16200000">
            <a:off x="2689338" y="2956541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E5F8AAE-CFD2-E90C-12BF-37DAB4CF5C68}"/>
              </a:ext>
            </a:extLst>
          </p:cNvPr>
          <p:cNvSpPr txBox="1"/>
          <p:nvPr/>
        </p:nvSpPr>
        <p:spPr>
          <a:xfrm rot="16200000">
            <a:off x="2783794" y="2794212"/>
            <a:ext cx="1261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9B3A4FD-855A-3AA5-965C-6C42FDDBCE59}"/>
              </a:ext>
            </a:extLst>
          </p:cNvPr>
          <p:cNvSpPr txBox="1"/>
          <p:nvPr/>
        </p:nvSpPr>
        <p:spPr>
          <a:xfrm rot="16200000">
            <a:off x="2558952" y="2354667"/>
            <a:ext cx="21578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6817B0DC-AB08-3932-7915-2A7C6C99BC17}"/>
              </a:ext>
            </a:extLst>
          </p:cNvPr>
          <p:cNvCxnSpPr>
            <a:cxnSpLocks/>
          </p:cNvCxnSpPr>
          <p:nvPr/>
        </p:nvCxnSpPr>
        <p:spPr>
          <a:xfrm flipV="1">
            <a:off x="4198338" y="1332579"/>
            <a:ext cx="1482722" cy="22148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A98F0E25-D59F-1094-8EE7-CC9DDF33C28C}"/>
              </a:ext>
            </a:extLst>
          </p:cNvPr>
          <p:cNvSpPr txBox="1"/>
          <p:nvPr/>
        </p:nvSpPr>
        <p:spPr>
          <a:xfrm rot="16200000">
            <a:off x="5287048" y="318870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B55A935-5E57-B623-1D14-0DD15FFE6FA2}"/>
              </a:ext>
            </a:extLst>
          </p:cNvPr>
          <p:cNvSpPr txBox="1"/>
          <p:nvPr/>
        </p:nvSpPr>
        <p:spPr>
          <a:xfrm rot="16200000">
            <a:off x="3832448" y="2909738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9DB43B9-67E5-1350-B2C3-39C46B5D4E9E}"/>
              </a:ext>
            </a:extLst>
          </p:cNvPr>
          <p:cNvSpPr txBox="1"/>
          <p:nvPr/>
        </p:nvSpPr>
        <p:spPr>
          <a:xfrm rot="16200000">
            <a:off x="3924519" y="2750852"/>
            <a:ext cx="1295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L-NG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BD7CE5F-88CC-F8FC-773A-911C9F544080}"/>
              </a:ext>
            </a:extLst>
          </p:cNvPr>
          <p:cNvSpPr txBox="1"/>
          <p:nvPr/>
        </p:nvSpPr>
        <p:spPr>
          <a:xfrm rot="16200000">
            <a:off x="4332482" y="2921572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160AF3B-9F7A-C96F-082D-70B94AC9131F}"/>
              </a:ext>
            </a:extLst>
          </p:cNvPr>
          <p:cNvSpPr txBox="1"/>
          <p:nvPr/>
        </p:nvSpPr>
        <p:spPr>
          <a:xfrm rot="16200000">
            <a:off x="4413686" y="2759243"/>
            <a:ext cx="1261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F1A2B1B-EFAA-F59E-A2D9-B9F9CDB08A9A}"/>
              </a:ext>
            </a:extLst>
          </p:cNvPr>
          <p:cNvSpPr txBox="1"/>
          <p:nvPr/>
        </p:nvSpPr>
        <p:spPr>
          <a:xfrm rot="16200000">
            <a:off x="4301021" y="2432950"/>
            <a:ext cx="19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621AE57A-09B5-4E53-E6DD-01893CFCE523}"/>
              </a:ext>
            </a:extLst>
          </p:cNvPr>
          <p:cNvCxnSpPr/>
          <p:nvPr/>
        </p:nvCxnSpPr>
        <p:spPr>
          <a:xfrm>
            <a:off x="2141917" y="4152975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EDFB8F3D-80FD-EEBB-3BB3-E493BC227430}"/>
              </a:ext>
            </a:extLst>
          </p:cNvPr>
          <p:cNvCxnSpPr/>
          <p:nvPr/>
        </p:nvCxnSpPr>
        <p:spPr>
          <a:xfrm>
            <a:off x="2141918" y="3818357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AEECB350-9720-4E23-A553-780210C57429}"/>
              </a:ext>
            </a:extLst>
          </p:cNvPr>
          <p:cNvCxnSpPr/>
          <p:nvPr/>
        </p:nvCxnSpPr>
        <p:spPr>
          <a:xfrm>
            <a:off x="2141918" y="4535154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10D924F1-296D-A754-F5C3-4FE6D5D5BD04}"/>
              </a:ext>
            </a:extLst>
          </p:cNvPr>
          <p:cNvCxnSpPr/>
          <p:nvPr/>
        </p:nvCxnSpPr>
        <p:spPr>
          <a:xfrm>
            <a:off x="2141918" y="5156824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CBCDC593-BBB9-B42E-3DD1-FDEF83EBF304}"/>
              </a:ext>
            </a:extLst>
          </p:cNvPr>
          <p:cNvSpPr txBox="1"/>
          <p:nvPr/>
        </p:nvSpPr>
        <p:spPr>
          <a:xfrm>
            <a:off x="1745575" y="366446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34FB742-5ED7-FA7D-22AC-EDCB857EC651}"/>
              </a:ext>
            </a:extLst>
          </p:cNvPr>
          <p:cNvSpPr txBox="1"/>
          <p:nvPr/>
        </p:nvSpPr>
        <p:spPr>
          <a:xfrm>
            <a:off x="1745575" y="399908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5630625-65B6-710B-1CCB-1C1731022823}"/>
              </a:ext>
            </a:extLst>
          </p:cNvPr>
          <p:cNvSpPr txBox="1"/>
          <p:nvPr/>
        </p:nvSpPr>
        <p:spPr>
          <a:xfrm>
            <a:off x="1725588" y="438126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B534806-926A-64DD-1471-81C92B09DDF6}"/>
              </a:ext>
            </a:extLst>
          </p:cNvPr>
          <p:cNvSpPr txBox="1"/>
          <p:nvPr/>
        </p:nvSpPr>
        <p:spPr>
          <a:xfrm>
            <a:off x="1742034" y="500293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4061953-6631-1CF0-F54F-C899967A06AC}"/>
              </a:ext>
            </a:extLst>
          </p:cNvPr>
          <p:cNvSpPr txBox="1"/>
          <p:nvPr/>
        </p:nvSpPr>
        <p:spPr>
          <a:xfrm>
            <a:off x="1496198" y="5492731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EBB2F971-4473-8EDC-D0F6-282CCAF8A926}"/>
              </a:ext>
            </a:extLst>
          </p:cNvPr>
          <p:cNvCxnSpPr/>
          <p:nvPr/>
        </p:nvCxnSpPr>
        <p:spPr>
          <a:xfrm>
            <a:off x="2141917" y="3612948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74FB6940-5176-B31F-CFC5-27E73F47B078}"/>
              </a:ext>
            </a:extLst>
          </p:cNvPr>
          <p:cNvCxnSpPr/>
          <p:nvPr/>
        </p:nvCxnSpPr>
        <p:spPr>
          <a:xfrm>
            <a:off x="2141917" y="3387967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8567BF57-E25C-01FB-A26E-2FD6CB4E02C9}"/>
              </a:ext>
            </a:extLst>
          </p:cNvPr>
          <p:cNvSpPr txBox="1"/>
          <p:nvPr/>
        </p:nvSpPr>
        <p:spPr>
          <a:xfrm>
            <a:off x="1661299" y="3459059"/>
            <a:ext cx="4694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929103F-E6E0-F5F1-6451-C054B7DE625B}"/>
              </a:ext>
            </a:extLst>
          </p:cNvPr>
          <p:cNvSpPr txBox="1"/>
          <p:nvPr/>
        </p:nvSpPr>
        <p:spPr>
          <a:xfrm>
            <a:off x="1672430" y="324055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92F7BFF-99F0-E824-CE57-902E5A680AE2}"/>
              </a:ext>
            </a:extLst>
          </p:cNvPr>
          <p:cNvSpPr txBox="1"/>
          <p:nvPr/>
        </p:nvSpPr>
        <p:spPr>
          <a:xfrm>
            <a:off x="7616986" y="900947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J2 IP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36B53BA4-999C-2760-3971-43E4E32E460F}"/>
              </a:ext>
            </a:extLst>
          </p:cNvPr>
          <p:cNvCxnSpPr>
            <a:cxnSpLocks/>
          </p:cNvCxnSpPr>
          <p:nvPr/>
        </p:nvCxnSpPr>
        <p:spPr>
          <a:xfrm flipV="1">
            <a:off x="7136349" y="1145539"/>
            <a:ext cx="1482722" cy="22148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3974D823-86D3-8342-F066-38A3B1FAF5F9}"/>
              </a:ext>
            </a:extLst>
          </p:cNvPr>
          <p:cNvSpPr txBox="1"/>
          <p:nvPr/>
        </p:nvSpPr>
        <p:spPr>
          <a:xfrm>
            <a:off x="9230050" y="841435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8F9F36AF-7001-0864-FE83-77ACEBECA166}"/>
              </a:ext>
            </a:extLst>
          </p:cNvPr>
          <p:cNvCxnSpPr>
            <a:cxnSpLocks/>
          </p:cNvCxnSpPr>
          <p:nvPr/>
        </p:nvCxnSpPr>
        <p:spPr>
          <a:xfrm flipV="1">
            <a:off x="8806950" y="1116765"/>
            <a:ext cx="1482722" cy="22148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CB4AB671-13E7-50CC-88E4-2A475E31BB5E}"/>
              </a:ext>
            </a:extLst>
          </p:cNvPr>
          <p:cNvSpPr txBox="1"/>
          <p:nvPr/>
        </p:nvSpPr>
        <p:spPr>
          <a:xfrm rot="16200000">
            <a:off x="9828540" y="288668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CD052EF-AA3E-8E8C-FD68-C855FA88AAC6}"/>
              </a:ext>
            </a:extLst>
          </p:cNvPr>
          <p:cNvSpPr txBox="1"/>
          <p:nvPr/>
        </p:nvSpPr>
        <p:spPr>
          <a:xfrm rot="16200000">
            <a:off x="8414556" y="2601160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D6E4F811-EB5A-406E-1142-0A39033D58C3}"/>
              </a:ext>
            </a:extLst>
          </p:cNvPr>
          <p:cNvSpPr txBox="1"/>
          <p:nvPr/>
        </p:nvSpPr>
        <p:spPr>
          <a:xfrm rot="16200000">
            <a:off x="8513253" y="2442274"/>
            <a:ext cx="1295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L-NG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15E4898-E515-A1C6-90AE-39D709275248}"/>
              </a:ext>
            </a:extLst>
          </p:cNvPr>
          <p:cNvSpPr txBox="1"/>
          <p:nvPr/>
        </p:nvSpPr>
        <p:spPr>
          <a:xfrm rot="16200000">
            <a:off x="8927842" y="2612994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47EEEA5-C443-F40E-527B-4E538405F05B}"/>
              </a:ext>
            </a:extLst>
          </p:cNvPr>
          <p:cNvSpPr txBox="1"/>
          <p:nvPr/>
        </p:nvSpPr>
        <p:spPr>
          <a:xfrm rot="16200000">
            <a:off x="8989168" y="2450665"/>
            <a:ext cx="1261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4F0E8642-ADBF-CEB4-2841-B4729432D463}"/>
              </a:ext>
            </a:extLst>
          </p:cNvPr>
          <p:cNvSpPr txBox="1"/>
          <p:nvPr/>
        </p:nvSpPr>
        <p:spPr>
          <a:xfrm rot="16200000">
            <a:off x="8849999" y="2111120"/>
            <a:ext cx="19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ECFCD6CE-DD92-8824-D5D2-A3EAC199E922}"/>
              </a:ext>
            </a:extLst>
          </p:cNvPr>
          <p:cNvSpPr txBox="1"/>
          <p:nvPr/>
        </p:nvSpPr>
        <p:spPr>
          <a:xfrm rot="16200000">
            <a:off x="8269501" y="2885655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D82B22B9-6C8E-20AF-632C-56619E517596}"/>
              </a:ext>
            </a:extLst>
          </p:cNvPr>
          <p:cNvSpPr txBox="1"/>
          <p:nvPr/>
        </p:nvSpPr>
        <p:spPr>
          <a:xfrm rot="16200000">
            <a:off x="6877196" y="2591693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7EC670F4-A146-8A70-5A8A-1784ABC2AB4F}"/>
              </a:ext>
            </a:extLst>
          </p:cNvPr>
          <p:cNvSpPr txBox="1"/>
          <p:nvPr/>
        </p:nvSpPr>
        <p:spPr>
          <a:xfrm rot="16200000">
            <a:off x="6949389" y="2432807"/>
            <a:ext cx="1295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L-NG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AA9484B4-FA80-0A21-BF16-FA0B989761B1}"/>
              </a:ext>
            </a:extLst>
          </p:cNvPr>
          <p:cNvSpPr txBox="1"/>
          <p:nvPr/>
        </p:nvSpPr>
        <p:spPr>
          <a:xfrm rot="16200000">
            <a:off x="7344100" y="2603527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F57E182-F6B7-DCCF-E62B-2C31BBC71777}"/>
              </a:ext>
            </a:extLst>
          </p:cNvPr>
          <p:cNvSpPr txBox="1"/>
          <p:nvPr/>
        </p:nvSpPr>
        <p:spPr>
          <a:xfrm rot="16200000">
            <a:off x="7398800" y="2441198"/>
            <a:ext cx="1261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AB3F301-2751-E2E8-F133-77263800BC7F}"/>
              </a:ext>
            </a:extLst>
          </p:cNvPr>
          <p:cNvSpPr txBox="1"/>
          <p:nvPr/>
        </p:nvSpPr>
        <p:spPr>
          <a:xfrm rot="16200000">
            <a:off x="7170839" y="1997434"/>
            <a:ext cx="21578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0AD16232-9434-935C-31F7-4E958171487D}"/>
              </a:ext>
            </a:extLst>
          </p:cNvPr>
          <p:cNvCxnSpPr/>
          <p:nvPr/>
        </p:nvCxnSpPr>
        <p:spPr>
          <a:xfrm>
            <a:off x="6841692" y="4041958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9C6539CD-E1FE-1B0D-F71F-08A12990BF2D}"/>
              </a:ext>
            </a:extLst>
          </p:cNvPr>
          <p:cNvCxnSpPr/>
          <p:nvPr/>
        </p:nvCxnSpPr>
        <p:spPr>
          <a:xfrm>
            <a:off x="6841693" y="3740470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6EB851E1-4973-B09E-DACC-110B24259394}"/>
              </a:ext>
            </a:extLst>
          </p:cNvPr>
          <p:cNvCxnSpPr/>
          <p:nvPr/>
        </p:nvCxnSpPr>
        <p:spPr>
          <a:xfrm>
            <a:off x="6841693" y="4417511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C8FE5BAE-71CF-FCD7-D26E-B5FB4E3915AC}"/>
              </a:ext>
            </a:extLst>
          </p:cNvPr>
          <p:cNvCxnSpPr/>
          <p:nvPr/>
        </p:nvCxnSpPr>
        <p:spPr>
          <a:xfrm>
            <a:off x="6841693" y="4986173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010733D9-0D12-5D9A-9E8F-CE91F7B1E0E7}"/>
              </a:ext>
            </a:extLst>
          </p:cNvPr>
          <p:cNvSpPr txBox="1"/>
          <p:nvPr/>
        </p:nvSpPr>
        <p:spPr>
          <a:xfrm>
            <a:off x="6445350" y="358658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8827FC5-10B4-A86D-29E2-258D813428D1}"/>
              </a:ext>
            </a:extLst>
          </p:cNvPr>
          <p:cNvSpPr txBox="1"/>
          <p:nvPr/>
        </p:nvSpPr>
        <p:spPr>
          <a:xfrm>
            <a:off x="6445350" y="388806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8CBC7C17-1F99-BE38-E16C-0790790AFE75}"/>
              </a:ext>
            </a:extLst>
          </p:cNvPr>
          <p:cNvSpPr txBox="1"/>
          <p:nvPr/>
        </p:nvSpPr>
        <p:spPr>
          <a:xfrm>
            <a:off x="6425363" y="42636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8456CDE4-213B-0F4D-3432-4A303D47B601}"/>
              </a:ext>
            </a:extLst>
          </p:cNvPr>
          <p:cNvSpPr txBox="1"/>
          <p:nvPr/>
        </p:nvSpPr>
        <p:spPr>
          <a:xfrm>
            <a:off x="6441809" y="483228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77A498DB-F1A7-8804-9DC9-29BA7FD7A50D}"/>
              </a:ext>
            </a:extLst>
          </p:cNvPr>
          <p:cNvSpPr txBox="1"/>
          <p:nvPr/>
        </p:nvSpPr>
        <p:spPr>
          <a:xfrm>
            <a:off x="6195973" y="546122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5162FABB-6665-FB6B-770C-07C3A4F7F7CE}"/>
              </a:ext>
            </a:extLst>
          </p:cNvPr>
          <p:cNvCxnSpPr/>
          <p:nvPr/>
        </p:nvCxnSpPr>
        <p:spPr>
          <a:xfrm>
            <a:off x="6841692" y="3369714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EEB3EB3D-E1D4-3A3D-067D-75238A70BBF4}"/>
              </a:ext>
            </a:extLst>
          </p:cNvPr>
          <p:cNvSpPr txBox="1"/>
          <p:nvPr/>
        </p:nvSpPr>
        <p:spPr>
          <a:xfrm>
            <a:off x="6372205" y="3222299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4227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Office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 Carvalho Schäfer</dc:creator>
  <cp:lastModifiedBy>Yasmin Carvalho Schäfer</cp:lastModifiedBy>
  <cp:revision>9</cp:revision>
  <dcterms:created xsi:type="dcterms:W3CDTF">2024-06-28T19:09:49Z</dcterms:created>
  <dcterms:modified xsi:type="dcterms:W3CDTF">2024-08-13T12:20:25Z</dcterms:modified>
</cp:coreProperties>
</file>